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_rels/notesSlide5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3.jpeg" ContentType="image/jpeg"/>
  <Override PartName="/ppt/media/image9.png" ContentType="image/png"/>
  <Override PartName="/ppt/media/image7.png" ContentType="image/png"/>
  <Override PartName="/ppt/media/image11.jpeg" ContentType="image/jpeg"/>
  <Override PartName="/ppt/media/image8.png" ContentType="image/png"/>
  <Override PartName="/ppt/media/image14.jpeg" ContentType="image/jpeg"/>
  <Override PartName="/ppt/media/image19.wmf" ContentType="image/x-wmf"/>
  <Override PartName="/ppt/media/image2.png" ContentType="image/png"/>
  <Override PartName="/ppt/media/image18.wmf" ContentType="image/x-wmf"/>
  <Override PartName="/ppt/media/image1.png" ContentType="image/png"/>
  <Override PartName="/ppt/media/image17.png" ContentType="image/png"/>
  <Override PartName="/ppt/media/image16.jpeg" ContentType="image/jpeg"/>
  <Override PartName="/ppt/media/image15.jpeg" ContentType="image/jpeg"/>
  <Override PartName="/ppt/media/image3.png" ContentType="image/png"/>
  <Override PartName="/ppt/media/image4.wmf" ContentType="image/x-wmf"/>
  <Override PartName="/ppt/media/image12.jpeg" ContentType="image/jpeg"/>
  <Override PartName="/ppt/media/image10.png" ContentType="image/png"/>
  <Override PartName="/ppt/media/image5.wmf" ContentType="image/x-wmf"/>
  <Override PartName="/ppt/media/image6.jpeg" ContentType="image/jpe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179680" y="-36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ECE7B0-99FA-48C8-9449-48021AA7D839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857320" y="514440"/>
            <a:ext cx="3429000" cy="2571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179680" y="6513120"/>
            <a:ext cx="3962520" cy="343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A1E02A-3292-402D-8F12-E4EA9377DC2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Rectangle 7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09331F-6553-41D5-A565-E73E81ED42F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78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80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Slide Number Placeholder 3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E6E0D6-57D6-4BC2-9DD5-A6B72E8E946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Rectangle 7"/>
          <p:cNvSpPr/>
          <p:nvPr/>
        </p:nvSpPr>
        <p:spPr>
          <a:xfrm>
            <a:off x="5180040" y="6513480"/>
            <a:ext cx="3962520" cy="34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D09A20-361B-492C-9D74-CCDC05C3815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1"/>
          <p:cNvSpPr>
            <a:spLocks noGrp="1"/>
          </p:cNvSpPr>
          <p:nvPr>
            <p:ph type="sldImg"/>
          </p:nvPr>
        </p:nvSpPr>
        <p:spPr>
          <a:xfrm>
            <a:off x="2857680" y="514440"/>
            <a:ext cx="3429000" cy="2571840"/>
          </a:xfrm>
          <a:prstGeom prst="rect">
            <a:avLst/>
          </a:prstGeom>
          <a:ln w="0">
            <a:noFill/>
          </a:ln>
        </p:spPr>
      </p:sp>
      <p:sp>
        <p:nvSpPr>
          <p:cNvPr id="184" name="PlaceHolder 2"/>
          <p:cNvSpPr>
            <a:spLocks noGrp="1"/>
          </p:cNvSpPr>
          <p:nvPr>
            <p:ph type="body"/>
          </p:nvPr>
        </p:nvSpPr>
        <p:spPr>
          <a:xfrm>
            <a:off x="914400" y="3257640"/>
            <a:ext cx="7315200" cy="308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just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Knockdown of DNAPKCs time course: Immunoblot analysis of whole cell extracts from WTK1 cells transfected without (mock) (M) or with (DNAPKcs) siRNA and probe with DNAPKCs (green) and ATM (red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DD12C-0DE1-4AB9-B790-1B0A3F6C0C5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C212F-FE54-4803-AD22-42996EC592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73BB9-16C2-4BAE-8835-DE101276AF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1A112F-1D6C-4C8D-B88D-5C9A57CF18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64CA6-A8C6-4A52-8D7E-AE0D2615DA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35EA9-26C2-4295-92BF-C1881292A8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19E6CD-5824-44F2-84F8-32B9C28FE9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42ADD3-9ECF-41C1-A78B-F23CEA0E4C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38F65-DAB8-4EF7-A0B0-111FC07054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E2B7E-B240-4F4E-BEFE-3D13CF388F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AD1C2F-9265-406E-AFD4-CB71A67B6A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3072E1-4F8E-447F-99BF-B5D84F1232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ED4DBE-3299-4CEE-8CF1-7D22C76E3D2E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69AEA3-F143-42CA-96E5-71EA8359C38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9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5.wmf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8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8.png"/><Relationship Id="rId7" Type="http://schemas.openxmlformats.org/officeDocument/2006/relationships/image" Target="../media/image10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image" Target="../media/image13.jpe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4.jpeg"/><Relationship Id="rId2" Type="http://schemas.openxmlformats.org/officeDocument/2006/relationships/image" Target="../media/image15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1"/>
          <p:cNvSpPr/>
          <p:nvPr/>
        </p:nvSpPr>
        <p:spPr>
          <a:xfrm>
            <a:off x="3930480" y="382680"/>
            <a:ext cx="1843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2"/>
          <p:cNvSpPr/>
          <p:nvPr/>
        </p:nvSpPr>
        <p:spPr>
          <a:xfrm>
            <a:off x="1066680" y="914400"/>
            <a:ext cx="701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Group 23"/>
          <p:cNvGrpSpPr/>
          <p:nvPr/>
        </p:nvGrpSpPr>
        <p:grpSpPr>
          <a:xfrm>
            <a:off x="1036800" y="1371600"/>
            <a:ext cx="6735600" cy="3126240"/>
            <a:chOff x="1036800" y="1371600"/>
            <a:chExt cx="6735600" cy="3126240"/>
          </a:xfrm>
        </p:grpSpPr>
        <p:sp>
          <p:nvSpPr>
            <p:cNvPr id="51" name="Rectangle 844"/>
            <p:cNvSpPr/>
            <p:nvPr/>
          </p:nvSpPr>
          <p:spPr>
            <a:xfrm>
              <a:off x="3187800" y="1371600"/>
              <a:ext cx="183960" cy="442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866880"/>
                  <a:tab algn="l" pos="1733400"/>
                  <a:tab algn="l" pos="2600280"/>
                  <a:tab algn="l" pos="3467160"/>
                  <a:tab algn="l" pos="4334040"/>
                  <a:tab algn="l" pos="5200560"/>
                  <a:tab algn="l" pos="6067440"/>
                  <a:tab algn="l" pos="6934320"/>
                  <a:tab algn="l" pos="7800840"/>
                  <a:tab algn="l" pos="8667720"/>
                  <a:tab algn="l" pos="9534600"/>
                  <a:tab algn="l" pos="1040148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Picture 724" descr=""/>
            <p:cNvPicPr/>
            <p:nvPr/>
          </p:nvPicPr>
          <p:blipFill>
            <a:blip r:embed="rId1"/>
            <a:srcRect l="21567" t="32311" r="0" b="0"/>
            <a:stretch/>
          </p:blipFill>
          <p:spPr>
            <a:xfrm>
              <a:off x="5473800" y="2971800"/>
              <a:ext cx="2298600" cy="117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725" descr="5555"/>
            <p:cNvPicPr/>
            <p:nvPr/>
          </p:nvPicPr>
          <p:blipFill>
            <a:blip r:embed="rId2"/>
            <a:srcRect l="13967" t="48839" r="16290" b="34902"/>
            <a:stretch/>
          </p:blipFill>
          <p:spPr>
            <a:xfrm>
              <a:off x="3578400" y="3260520"/>
              <a:ext cx="1379520" cy="14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726" descr="~AUT0002"/>
            <p:cNvPicPr/>
            <p:nvPr/>
          </p:nvPicPr>
          <p:blipFill>
            <a:blip r:embed="rId3">
              <a:lum bright="24000"/>
            </a:blip>
            <a:srcRect l="86725" t="86938" r="0" b="10214"/>
            <a:stretch/>
          </p:blipFill>
          <p:spPr>
            <a:xfrm>
              <a:off x="3564000" y="3691080"/>
              <a:ext cx="1550880" cy="274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 Box 727"/>
            <p:cNvSpPr/>
            <p:nvPr/>
          </p:nvSpPr>
          <p:spPr>
            <a:xfrm>
              <a:off x="2619360" y="3700440"/>
              <a:ext cx="55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新宋体"/>
                </a:rPr>
                <a:t>acti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728"/>
            <p:cNvSpPr/>
            <p:nvPr/>
          </p:nvSpPr>
          <p:spPr>
            <a:xfrm>
              <a:off x="3477240" y="2668680"/>
              <a:ext cx="55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729"/>
            <p:cNvSpPr/>
            <p:nvPr/>
          </p:nvSpPr>
          <p:spPr>
            <a:xfrm>
              <a:off x="3918960" y="266868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RNA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730"/>
            <p:cNvSpPr/>
            <p:nvPr/>
          </p:nvSpPr>
          <p:spPr>
            <a:xfrm>
              <a:off x="4484160" y="266868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RNA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733"/>
            <p:cNvSpPr/>
            <p:nvPr/>
          </p:nvSpPr>
          <p:spPr>
            <a:xfrm>
              <a:off x="5690160" y="2668680"/>
              <a:ext cx="55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734"/>
            <p:cNvSpPr/>
            <p:nvPr/>
          </p:nvSpPr>
          <p:spPr>
            <a:xfrm>
              <a:off x="3507480" y="1981080"/>
              <a:ext cx="1770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Li Fraumeni (087)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735"/>
            <p:cNvSpPr/>
            <p:nvPr/>
          </p:nvSpPr>
          <p:spPr>
            <a:xfrm>
              <a:off x="6451200" y="1981080"/>
              <a:ext cx="429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5C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737"/>
            <p:cNvSpPr/>
            <p:nvPr/>
          </p:nvSpPr>
          <p:spPr>
            <a:xfrm>
              <a:off x="2506680" y="2346120"/>
              <a:ext cx="183960" cy="30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738"/>
            <p:cNvSpPr/>
            <p:nvPr/>
          </p:nvSpPr>
          <p:spPr>
            <a:xfrm>
              <a:off x="5332680" y="2332080"/>
              <a:ext cx="182520" cy="30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6"/>
            <p:cNvSpPr/>
            <p:nvPr/>
          </p:nvSpPr>
          <p:spPr>
            <a:xfrm>
              <a:off x="2179800" y="3124080"/>
              <a:ext cx="11476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tankyrase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7"/>
            <p:cNvSpPr/>
            <p:nvPr/>
          </p:nvSpPr>
          <p:spPr>
            <a:xfrm>
              <a:off x="3570480" y="4221360"/>
              <a:ext cx="379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100        &lt;1        &lt;1                            100       &lt;1          &lt;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729"/>
            <p:cNvSpPr/>
            <p:nvPr/>
          </p:nvSpPr>
          <p:spPr>
            <a:xfrm>
              <a:off x="6160680" y="266868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RNA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730"/>
            <p:cNvSpPr/>
            <p:nvPr/>
          </p:nvSpPr>
          <p:spPr>
            <a:xfrm>
              <a:off x="6824160" y="2668680"/>
              <a:ext cx="688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65520"/>
                  <a:tab algn="l" pos="9131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siRNA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0"/>
            <p:cNvSpPr/>
            <p:nvPr/>
          </p:nvSpPr>
          <p:spPr>
            <a:xfrm>
              <a:off x="1036800" y="4191120"/>
              <a:ext cx="2217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relative tankyrase 1 level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23"/>
            <p:cNvSpPr/>
            <p:nvPr/>
          </p:nvSpPr>
          <p:spPr>
            <a:xfrm>
              <a:off x="3398760" y="3124080"/>
              <a:ext cx="4343400" cy="8625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Bef>
                  <a:spcPts val="125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TextBox 24"/>
          <p:cNvSpPr/>
          <p:nvPr/>
        </p:nvSpPr>
        <p:spPr>
          <a:xfrm>
            <a:off x="430200" y="5597640"/>
            <a:ext cx="83329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1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Effective knockdown of tankyrase 1 protein levels with two different siRNA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Western blot analyses of tankyrase 1 in Li-Fraumeni 087 (ALT) and 5C primary human fibroblasts (telomerase negative) 18 hr after siRNA transfection. Upper bands probed with tankyrase 1 antibody; lower bands with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.  Percentages of protein remaining are shown below; all values were normaliz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nd the mock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 Box 2"/>
          <p:cNvSpPr/>
          <p:nvPr/>
        </p:nvSpPr>
        <p:spPr>
          <a:xfrm>
            <a:off x="3666600" y="38268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73" name=""/>
          <p:cNvGraphicFramePr/>
          <p:nvPr/>
        </p:nvGraphicFramePr>
        <p:xfrm>
          <a:off x="2065320" y="914400"/>
          <a:ext cx="5665680" cy="5181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7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065320" y="914400"/>
                    <a:ext cx="5665680" cy="5181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5" name="TextBox 4"/>
          <p:cNvSpPr/>
          <p:nvPr/>
        </p:nvSpPr>
        <p:spPr>
          <a:xfrm>
            <a:off x="380880" y="5791320"/>
            <a:ext cx="8458200" cy="126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8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Spontaneous and IR-induced mutagenesis after depletion or inhibition of DNA-PKcs and/or tankyrase 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WTK1 lymphoblasts were mock transfected (M) or treated with DNA-PKcs siRNA (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DNA-PKcs inhibitor Nu7026 (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tankyrase 1 siRNA (T), or combinations thereof i.e., DNA-PKcs siRNA plus DNA-PKcs inhibitor (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/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or tankyrase 1 siRNA plus DNA-PKcs inhibitor (T/P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 Cells were irradiated with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rays or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5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e ions and the MFs determined three days later.  Data are means of at least three independent determinations, and error bars are standard devia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 Box 3"/>
          <p:cNvSpPr/>
          <p:nvPr/>
        </p:nvSpPr>
        <p:spPr>
          <a:xfrm>
            <a:off x="3376080" y="54468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2" name="Object 2"/>
          <p:cNvGraphicFramePr/>
          <p:nvPr/>
        </p:nvGraphicFramePr>
        <p:xfrm>
          <a:off x="762120" y="1660680"/>
          <a:ext cx="3733560" cy="2805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62120" y="1660680"/>
                    <a:ext cx="3733560" cy="280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Text Box 5"/>
          <p:cNvSpPr/>
          <p:nvPr/>
        </p:nvSpPr>
        <p:spPr>
          <a:xfrm>
            <a:off x="1911960" y="1371600"/>
            <a:ext cx="143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Li-Fraumen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6"/>
          <p:cNvSpPr/>
          <p:nvPr/>
        </p:nvSpPr>
        <p:spPr>
          <a:xfrm>
            <a:off x="6230880" y="137160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5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6" name="Object 3"/>
          <p:cNvGraphicFramePr/>
          <p:nvPr/>
        </p:nvGraphicFramePr>
        <p:xfrm>
          <a:off x="4572000" y="1657440"/>
          <a:ext cx="3809880" cy="2779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7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572000" y="1657440"/>
                    <a:ext cx="3809880" cy="2779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8" name=""/>
          <p:cNvGraphicFramePr/>
          <p:nvPr/>
        </p:nvGraphicFramePr>
        <p:xfrm>
          <a:off x="1295280" y="3475080"/>
          <a:ext cx="2286000" cy="473040"/>
        </p:xfrm>
        <a:graphic>
          <a:graphicData uri="http://schemas.openxmlformats.org/drawingml/2006/table">
            <a:tbl>
              <a:tblPr/>
              <a:tblGrid>
                <a:gridCol w="1067040"/>
                <a:gridCol w="380880"/>
                <a:gridCol w="380880"/>
                <a:gridCol w="457200"/>
              </a:tblGrid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G2/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ock transfec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5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3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Tankyrase 1 s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9" name=""/>
          <p:cNvGraphicFramePr/>
          <p:nvPr/>
        </p:nvGraphicFramePr>
        <p:xfrm>
          <a:off x="5257800" y="3459240"/>
          <a:ext cx="2209680" cy="473040"/>
        </p:xfrm>
        <a:graphic>
          <a:graphicData uri="http://schemas.openxmlformats.org/drawingml/2006/table">
            <a:tbl>
              <a:tblPr/>
              <a:tblGrid>
                <a:gridCol w="990720"/>
                <a:gridCol w="380880"/>
                <a:gridCol w="380880"/>
                <a:gridCol w="457200"/>
              </a:tblGrid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G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G2/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Mock transfec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58040"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Tankyrase 1 s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Calibri"/>
                          <a:ea typeface="Calibri"/>
                        </a:rPr>
                        <a:t>0.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0" name="TextBox 10"/>
          <p:cNvSpPr/>
          <p:nvPr/>
        </p:nvSpPr>
        <p:spPr>
          <a:xfrm>
            <a:off x="304920" y="5384880"/>
            <a:ext cx="86104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2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Increased radiation-induced cell killing (reduced survival) with reduced levels of tankyrase 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Li-Fraumeni and 5C fibroblasts were treated with tankyrase 1 siRNA, then were expos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rays and the surviving fractions determined by clonogenic assay.  Points are averages of three experiments; error bars are standard deviations.  Mock transfection (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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tankyrase 1 siRNA transfection (o).  Cell cycle distributions were assessed by flow cytometry and found to be unaffected by tankyrase 1 depletion.  Cell cycle analyses were performed as described on the next pag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TextBox 2"/>
          <p:cNvSpPr/>
          <p:nvPr/>
        </p:nvSpPr>
        <p:spPr>
          <a:xfrm>
            <a:off x="990720" y="1563840"/>
            <a:ext cx="7315200" cy="222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ell cycle distributions were determined as follows: eighteen hours after transfection with tankyrase 1 siRNA, or mock-transfection with Lipofectamine 2000 reagent only, cells were trypsinized and resuspended in two ml cold PBS. Two ml cold 100% ethanol was added dropwise while vortexing the cells vigorously.  Three ml cold 100% ethanol was added to bring the final ethanol concentration to 70%.  Fixed samples were refrigerated for a minimum of 20 minutes before staining. Ethanol was aspirated, and cell pellets resuspended in 1 ml of propidium iodide (PI, 50ug/ml in PBS; Invitrogen) with RNAse (40 KU/ml; Sigma-Aldrich) added. All cell samples were analyzed with the EPICS IV Flow Cytometer (DakoCytomation, Inc., Fort Collins, CO) using a 488 nm laser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"/>
          <p:cNvSpPr/>
          <p:nvPr/>
        </p:nvSpPr>
        <p:spPr>
          <a:xfrm>
            <a:off x="2216160" y="382680"/>
            <a:ext cx="425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2, continu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Text Box 2"/>
          <p:cNvSpPr/>
          <p:nvPr/>
        </p:nvSpPr>
        <p:spPr>
          <a:xfrm>
            <a:off x="3361680" y="39204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Group 21"/>
          <p:cNvGrpSpPr/>
          <p:nvPr/>
        </p:nvGrpSpPr>
        <p:grpSpPr>
          <a:xfrm>
            <a:off x="914400" y="1371600"/>
            <a:ext cx="7375320" cy="4026960"/>
            <a:chOff x="914400" y="1371600"/>
            <a:chExt cx="7375320" cy="4026960"/>
          </a:xfrm>
        </p:grpSpPr>
        <p:sp>
          <p:nvSpPr>
            <p:cNvPr id="85" name="TextBox 7"/>
            <p:cNvSpPr/>
            <p:nvPr/>
          </p:nvSpPr>
          <p:spPr>
            <a:xfrm>
              <a:off x="914400" y="1371600"/>
              <a:ext cx="6019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                         </a:t>
              </a: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marker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        Mock         24 hr     48 hr       72 hr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6" name="Group 4"/>
            <p:cNvGrpSpPr/>
            <p:nvPr/>
          </p:nvGrpSpPr>
          <p:grpSpPr>
            <a:xfrm>
              <a:off x="2361960" y="1814400"/>
              <a:ext cx="5927760" cy="2629080"/>
              <a:chOff x="2361960" y="1814400"/>
              <a:chExt cx="5927760" cy="2629080"/>
            </a:xfrm>
          </p:grpSpPr>
          <p:pic>
            <p:nvPicPr>
              <p:cNvPr id="87" name="Picture 5" descr="tankPK72hrs"/>
              <p:cNvPicPr/>
              <p:nvPr/>
            </p:nvPicPr>
            <p:blipFill>
              <a:blip r:embed="rId1"/>
              <a:stretch/>
            </p:blipFill>
            <p:spPr>
              <a:xfrm>
                <a:off x="2361960" y="1814400"/>
                <a:ext cx="4267080" cy="1523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8" name="TextBox 8"/>
              <p:cNvSpPr/>
              <p:nvPr/>
            </p:nvSpPr>
            <p:spPr>
              <a:xfrm>
                <a:off x="6689520" y="1814400"/>
                <a:ext cx="16002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</a:rPr>
                  <a:t>DNA-PKcs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9" name="Picture 9" descr=""/>
              <p:cNvPicPr/>
              <p:nvPr/>
            </p:nvPicPr>
            <p:blipFill>
              <a:blip r:embed="rId2"/>
              <a:stretch/>
            </p:blipFill>
            <p:spPr>
              <a:xfrm>
                <a:off x="2361960" y="3473280"/>
                <a:ext cx="4267080" cy="9702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90" name="Rectangle 8"/>
              <p:cNvSpPr/>
              <p:nvPr/>
            </p:nvSpPr>
            <p:spPr>
              <a:xfrm>
                <a:off x="2361960" y="2805120"/>
                <a:ext cx="4343400" cy="75960"/>
              </a:xfrm>
              <a:prstGeom prst="rect">
                <a:avLst/>
              </a:prstGeom>
              <a:solidFill>
                <a:srgbClr val="ffffff"/>
              </a:solidFill>
              <a:ln w="255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 Box 9"/>
              <p:cNvSpPr/>
              <p:nvPr/>
            </p:nvSpPr>
            <p:spPr>
              <a:xfrm>
                <a:off x="6690960" y="2896920"/>
                <a:ext cx="13176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</a:rPr>
                  <a:t>tankyrase 1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 Box 10"/>
              <p:cNvSpPr/>
              <p:nvPr/>
            </p:nvSpPr>
            <p:spPr>
              <a:xfrm>
                <a:off x="6690960" y="3909960"/>
                <a:ext cx="6638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</a:rPr>
                  <a:t>actin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 Box 11"/>
              <p:cNvSpPr/>
              <p:nvPr/>
            </p:nvSpPr>
            <p:spPr>
              <a:xfrm>
                <a:off x="3419280" y="1830240"/>
                <a:ext cx="3200400" cy="376200"/>
              </a:xfrm>
              <a:prstGeom prst="rect">
                <a:avLst/>
              </a:prstGeom>
              <a:noFill/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 Box 12"/>
              <p:cNvSpPr/>
              <p:nvPr/>
            </p:nvSpPr>
            <p:spPr>
              <a:xfrm>
                <a:off x="3417480" y="2908080"/>
                <a:ext cx="3200400" cy="376200"/>
              </a:xfrm>
              <a:prstGeom prst="rect">
                <a:avLst/>
              </a:prstGeom>
              <a:noFill/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5" name="Text Box 16"/>
            <p:cNvSpPr/>
            <p:nvPr/>
          </p:nvSpPr>
          <p:spPr>
            <a:xfrm>
              <a:off x="3565440" y="4670640"/>
              <a:ext cx="3216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       7              7             9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 Box 17"/>
            <p:cNvSpPr/>
            <p:nvPr/>
          </p:nvSpPr>
          <p:spPr>
            <a:xfrm>
              <a:off x="3565440" y="5091480"/>
              <a:ext cx="3216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     &lt;1             &lt;1            1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 Box 13"/>
            <p:cNvSpPr/>
            <p:nvPr/>
          </p:nvSpPr>
          <p:spPr>
            <a:xfrm>
              <a:off x="6568560" y="4670640"/>
              <a:ext cx="1053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DNA-PK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 Box 14"/>
            <p:cNvSpPr/>
            <p:nvPr/>
          </p:nvSpPr>
          <p:spPr>
            <a:xfrm>
              <a:off x="6695280" y="5015160"/>
              <a:ext cx="1002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tankyrase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8"/>
            <p:cNvSpPr/>
            <p:nvPr/>
          </p:nvSpPr>
          <p:spPr>
            <a:xfrm>
              <a:off x="1448280" y="2905200"/>
              <a:ext cx="785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150 k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19"/>
            <p:cNvSpPr/>
            <p:nvPr/>
          </p:nvSpPr>
          <p:spPr>
            <a:xfrm>
              <a:off x="1451520" y="2295360"/>
              <a:ext cx="785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250 k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1" name="TextBox 20"/>
          <p:cNvSpPr/>
          <p:nvPr/>
        </p:nvSpPr>
        <p:spPr>
          <a:xfrm>
            <a:off x="152280" y="5867280"/>
            <a:ext cx="88394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Tankyrase 1 siRNA knockdown reduces DNA-PKcs protein levels in WTK1 human lymphoblast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Cells were transfected with tankyrase 1 siRNA or were mock transfected. Protein levels of DNA-PKcs, tankyrase 1, and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were determined 24, 48 or 72 hr after transfection.  Time course demonstrates tandem reduction and recovery of tankyrase 1 and DNA-PKcs.  Percentages of protein remaining are shown below the western; all values were normaliz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nd the mock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Picture 3" descr=""/>
          <p:cNvPicPr/>
          <p:nvPr/>
        </p:nvPicPr>
        <p:blipFill>
          <a:blip r:embed="rId1"/>
          <a:srcRect l="51861" t="27193" r="0" b="59525"/>
          <a:stretch/>
        </p:blipFill>
        <p:spPr>
          <a:xfrm>
            <a:off x="2438280" y="2743200"/>
            <a:ext cx="1630440" cy="76212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2" descr=""/>
          <p:cNvPicPr/>
          <p:nvPr/>
        </p:nvPicPr>
        <p:blipFill>
          <a:blip r:embed="rId2"/>
          <a:srcRect l="44948" t="22405" r="32615" b="64453"/>
          <a:stretch/>
        </p:blipFill>
        <p:spPr>
          <a:xfrm>
            <a:off x="1066680" y="2743200"/>
            <a:ext cx="609840" cy="76212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3" descr=""/>
          <p:cNvPicPr/>
          <p:nvPr/>
        </p:nvPicPr>
        <p:blipFill>
          <a:blip r:embed="rId3"/>
          <a:srcRect l="2245" t="27193" r="75251" b="59525"/>
          <a:stretch/>
        </p:blipFill>
        <p:spPr>
          <a:xfrm>
            <a:off x="1676520" y="2743200"/>
            <a:ext cx="761760" cy="76212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3" descr=""/>
          <p:cNvPicPr/>
          <p:nvPr/>
        </p:nvPicPr>
        <p:blipFill>
          <a:blip r:embed="rId4"/>
          <a:srcRect l="0" t="79168" r="77496" b="12863"/>
          <a:stretch/>
        </p:blipFill>
        <p:spPr>
          <a:xfrm>
            <a:off x="1752480" y="3733920"/>
            <a:ext cx="762120" cy="45720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2" descr=""/>
          <p:cNvPicPr/>
          <p:nvPr/>
        </p:nvPicPr>
        <p:blipFill>
          <a:blip r:embed="rId5"/>
          <a:srcRect l="33730" t="73890" r="38262" b="18210"/>
          <a:stretch/>
        </p:blipFill>
        <p:spPr>
          <a:xfrm>
            <a:off x="1066680" y="3733920"/>
            <a:ext cx="685800" cy="45720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3" descr=""/>
          <p:cNvPicPr/>
          <p:nvPr/>
        </p:nvPicPr>
        <p:blipFill>
          <a:blip r:embed="rId6"/>
          <a:srcRect l="51861" t="79168" r="0" b="12863"/>
          <a:stretch/>
        </p:blipFill>
        <p:spPr>
          <a:xfrm>
            <a:off x="2484360" y="3733920"/>
            <a:ext cx="1554120" cy="457200"/>
          </a:xfrm>
          <a:prstGeom prst="rect">
            <a:avLst/>
          </a:prstGeom>
          <a:ln w="0">
            <a:noFill/>
          </a:ln>
        </p:spPr>
      </p:pic>
      <p:sp>
        <p:nvSpPr>
          <p:cNvPr id="108" name="Text Box 11"/>
          <p:cNvSpPr/>
          <p:nvPr/>
        </p:nvSpPr>
        <p:spPr>
          <a:xfrm>
            <a:off x="0" y="2209680"/>
            <a:ext cx="457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G132 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           0            0                 12.5               50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12"/>
          <p:cNvSpPr/>
          <p:nvPr/>
        </p:nvSpPr>
        <p:spPr>
          <a:xfrm>
            <a:off x="76320" y="2057400"/>
            <a:ext cx="4495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XAV939 </a:t>
            </a:r>
            <a:r>
              <a:rPr b="0" lang="el-GR" sz="1100" spc="-1" strike="noStrike">
                <a:solidFill>
                  <a:srgbClr val="000000"/>
                </a:solidFill>
                <a:latin typeface="Arial"/>
              </a:rPr>
              <a:t>μ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           0         1.0                 1.0                  1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Chart 17" descr=""/>
          <p:cNvPicPr/>
          <p:nvPr/>
        </p:nvPicPr>
        <p:blipFill>
          <a:blip r:embed="rId7"/>
          <a:stretch/>
        </p:blipFill>
        <p:spPr>
          <a:xfrm>
            <a:off x="4565520" y="2127240"/>
            <a:ext cx="4584960" cy="3060720"/>
          </a:xfrm>
          <a:prstGeom prst="rect">
            <a:avLst/>
          </a:prstGeom>
          <a:ln w="0">
            <a:noFill/>
          </a:ln>
        </p:spPr>
      </p:pic>
      <p:sp>
        <p:nvSpPr>
          <p:cNvPr id="111" name="TextBox 18"/>
          <p:cNvSpPr/>
          <p:nvPr/>
        </p:nvSpPr>
        <p:spPr>
          <a:xfrm>
            <a:off x="0" y="4191120"/>
            <a:ext cx="4572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RE             100              23.56         34.17            37.9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11"/>
          <p:cNvSpPr/>
          <p:nvPr/>
        </p:nvSpPr>
        <p:spPr>
          <a:xfrm>
            <a:off x="3181320" y="685800"/>
            <a:ext cx="2762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4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13"/>
          <p:cNvSpPr/>
          <p:nvPr/>
        </p:nvSpPr>
        <p:spPr>
          <a:xfrm>
            <a:off x="228600" y="5934240"/>
            <a:ext cx="86868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.4.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Proteosome inhibition facilitates DNA-PKcs protein recovery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.  Comparison of XAV939 treatment alone to XAV939/MG132 combined treatment reveasl recovery of DNA-PKcs protein, suggesting tankyrase 1 prevents DNA-PKcs proteolytic degradation. Similar results were observed following siRNA depletion of tankyrase 1 and MG132 treatment (Figure 6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Text Box 21"/>
          <p:cNvSpPr/>
          <p:nvPr/>
        </p:nvSpPr>
        <p:spPr>
          <a:xfrm>
            <a:off x="1905120" y="1141560"/>
            <a:ext cx="24444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5" name="Group 19"/>
          <p:cNvGrpSpPr/>
          <p:nvPr/>
        </p:nvGrpSpPr>
        <p:grpSpPr>
          <a:xfrm>
            <a:off x="685800" y="1751040"/>
            <a:ext cx="8153280" cy="3201840"/>
            <a:chOff x="685800" y="1751040"/>
            <a:chExt cx="8153280" cy="3201840"/>
          </a:xfrm>
        </p:grpSpPr>
        <p:pic>
          <p:nvPicPr>
            <p:cNvPr id="116" name="Picture 3" descr="F:\pkpta2a.jpg"/>
            <p:cNvPicPr/>
            <p:nvPr/>
          </p:nvPicPr>
          <p:blipFill>
            <a:blip r:embed="rId1"/>
            <a:stretch/>
          </p:blipFill>
          <p:spPr>
            <a:xfrm>
              <a:off x="1447560" y="1751040"/>
              <a:ext cx="6400800" cy="2209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7" name="TextBox 7"/>
            <p:cNvSpPr/>
            <p:nvPr/>
          </p:nvSpPr>
          <p:spPr>
            <a:xfrm>
              <a:off x="914400" y="2209680"/>
              <a:ext cx="7086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hours post                     24        24       48          72        96       122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Box 8"/>
            <p:cNvSpPr/>
            <p:nvPr/>
          </p:nvSpPr>
          <p:spPr>
            <a:xfrm>
              <a:off x="2057040" y="1827000"/>
              <a:ext cx="156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marker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   Moc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9" name="Picture 13" descr="Oct3 T1I5"/>
            <p:cNvPicPr/>
            <p:nvPr/>
          </p:nvPicPr>
          <p:blipFill>
            <a:blip r:embed="rId2"/>
            <a:stretch/>
          </p:blipFill>
          <p:spPr>
            <a:xfrm>
              <a:off x="2057400" y="3884760"/>
              <a:ext cx="6477120" cy="30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Rectangle 14"/>
            <p:cNvSpPr/>
            <p:nvPr/>
          </p:nvSpPr>
          <p:spPr>
            <a:xfrm>
              <a:off x="6934320" y="4494240"/>
              <a:ext cx="1676160" cy="304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15"/>
            <p:cNvSpPr/>
            <p:nvPr/>
          </p:nvSpPr>
          <p:spPr>
            <a:xfrm>
              <a:off x="6934320" y="1904760"/>
              <a:ext cx="1904760" cy="2895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7"/>
            <p:cNvSpPr/>
            <p:nvPr/>
          </p:nvSpPr>
          <p:spPr>
            <a:xfrm>
              <a:off x="1752480" y="2590560"/>
              <a:ext cx="457200" cy="2362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5"/>
            <p:cNvSpPr/>
            <p:nvPr/>
          </p:nvSpPr>
          <p:spPr>
            <a:xfrm>
              <a:off x="917280" y="4417920"/>
              <a:ext cx="60876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DNA-PKcs     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 98              52              1 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  1            &lt;1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tankyrase 1     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113            181           132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	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 100         141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4" name="Picture 12" descr="Presentation3"/>
            <p:cNvPicPr/>
            <p:nvPr/>
          </p:nvPicPr>
          <p:blipFill>
            <a:blip r:embed="rId3"/>
            <a:stretch/>
          </p:blipFill>
          <p:spPr>
            <a:xfrm>
              <a:off x="2209680" y="3046320"/>
              <a:ext cx="4705200" cy="73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5" name="TextBox 9"/>
            <p:cNvSpPr/>
            <p:nvPr/>
          </p:nvSpPr>
          <p:spPr>
            <a:xfrm>
              <a:off x="685800" y="2668320"/>
              <a:ext cx="1371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DNA-PKc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Box 10"/>
            <p:cNvSpPr/>
            <p:nvPr/>
          </p:nvSpPr>
          <p:spPr>
            <a:xfrm>
              <a:off x="685800" y="3246480"/>
              <a:ext cx="1371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tankyrase 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16"/>
            <p:cNvSpPr/>
            <p:nvPr/>
          </p:nvSpPr>
          <p:spPr>
            <a:xfrm>
              <a:off x="1155600" y="38354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Box 8"/>
            <p:cNvSpPr/>
            <p:nvPr/>
          </p:nvSpPr>
          <p:spPr>
            <a:xfrm>
              <a:off x="4269240" y="1803240"/>
              <a:ext cx="196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DNA-PKcs siR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Line 17"/>
            <p:cNvSpPr/>
            <p:nvPr/>
          </p:nvSpPr>
          <p:spPr>
            <a:xfrm>
              <a:off x="3733560" y="2131920"/>
              <a:ext cx="3124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0" name="Text Box 18"/>
          <p:cNvSpPr/>
          <p:nvPr/>
        </p:nvSpPr>
        <p:spPr>
          <a:xfrm>
            <a:off x="3250800" y="696960"/>
            <a:ext cx="2686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5.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20"/>
          <p:cNvSpPr/>
          <p:nvPr/>
        </p:nvSpPr>
        <p:spPr>
          <a:xfrm>
            <a:off x="304920" y="5811840"/>
            <a:ext cx="85341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5.A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DNA-PKcs siRNA knockdown does not affect tankyrase 1 protein level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WTK1 lymphoblasts were treated with DNA-PKcs siRNA, then DNA-PKcs, tankyrase 1, and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protein levels, at 24, 48, 72, 96 and 122 hr after transfection, were measured by western blot.  Percentages of protein remaining are shown below; all values were normaliz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nd the mock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Rectangle 15"/>
          <p:cNvSpPr/>
          <p:nvPr/>
        </p:nvSpPr>
        <p:spPr>
          <a:xfrm>
            <a:off x="3285360" y="468360"/>
            <a:ext cx="2616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5.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" name="Group 19"/>
          <p:cNvGrpSpPr/>
          <p:nvPr/>
        </p:nvGrpSpPr>
        <p:grpSpPr>
          <a:xfrm>
            <a:off x="914400" y="1143000"/>
            <a:ext cx="6937200" cy="4952880"/>
            <a:chOff x="914400" y="1143000"/>
            <a:chExt cx="6937200" cy="4952880"/>
          </a:xfrm>
        </p:grpSpPr>
        <p:pic>
          <p:nvPicPr>
            <p:cNvPr id="134" name="Picture 6" descr=""/>
            <p:cNvPicPr/>
            <p:nvPr/>
          </p:nvPicPr>
          <p:blipFill>
            <a:blip r:embed="rId1"/>
            <a:stretch/>
          </p:blipFill>
          <p:spPr>
            <a:xfrm>
              <a:off x="914400" y="1143000"/>
              <a:ext cx="6937200" cy="4952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5" name="Text Box 7"/>
            <p:cNvSpPr/>
            <p:nvPr/>
          </p:nvSpPr>
          <p:spPr>
            <a:xfrm>
              <a:off x="1600200" y="1218960"/>
              <a:ext cx="6005520" cy="66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                        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Bef>
                  <a:spcPts val="4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hours post     24       24       48       72       96       122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TextBox 6"/>
            <p:cNvSpPr/>
            <p:nvPr/>
          </p:nvSpPr>
          <p:spPr>
            <a:xfrm>
              <a:off x="990360" y="2757240"/>
              <a:ext cx="1447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DNA-PKc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TextBox 8"/>
            <p:cNvSpPr/>
            <p:nvPr/>
          </p:nvSpPr>
          <p:spPr>
            <a:xfrm>
              <a:off x="1295280" y="3124080"/>
              <a:ext cx="884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AT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"/>
            <p:cNvSpPr/>
            <p:nvPr/>
          </p:nvSpPr>
          <p:spPr>
            <a:xfrm>
              <a:off x="2057400" y="3962520"/>
              <a:ext cx="4800600" cy="15238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0"/>
            <p:cNvSpPr/>
            <p:nvPr/>
          </p:nvSpPr>
          <p:spPr>
            <a:xfrm>
              <a:off x="6781680" y="4114800"/>
              <a:ext cx="990360" cy="533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 Box 11"/>
            <p:cNvSpPr/>
            <p:nvPr/>
          </p:nvSpPr>
          <p:spPr>
            <a:xfrm>
              <a:off x="1296720" y="4281480"/>
              <a:ext cx="6638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1" name="Picture 12" descr=""/>
            <p:cNvPicPr/>
            <p:nvPr/>
          </p:nvPicPr>
          <p:blipFill>
            <a:blip r:embed="rId2"/>
            <a:stretch/>
          </p:blipFill>
          <p:spPr>
            <a:xfrm>
              <a:off x="2514600" y="4038480"/>
              <a:ext cx="4343400" cy="685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2" name="Rectangle 14"/>
            <p:cNvSpPr/>
            <p:nvPr/>
          </p:nvSpPr>
          <p:spPr>
            <a:xfrm>
              <a:off x="1149480" y="4851360"/>
              <a:ext cx="53776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DNA-PKcs                 100        106            57           1              1.5         &lt;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ATM                           100        101            60           4               4           &lt;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5"/>
            <p:cNvSpPr/>
            <p:nvPr/>
          </p:nvSpPr>
          <p:spPr>
            <a:xfrm>
              <a:off x="6781680" y="4038480"/>
              <a:ext cx="75960" cy="6858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 Box 13"/>
            <p:cNvSpPr/>
            <p:nvPr/>
          </p:nvSpPr>
          <p:spPr>
            <a:xfrm>
              <a:off x="3365280" y="3128760"/>
              <a:ext cx="3429000" cy="37620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 Box 14"/>
            <p:cNvSpPr/>
            <p:nvPr/>
          </p:nvSpPr>
          <p:spPr>
            <a:xfrm>
              <a:off x="3365280" y="2682720"/>
              <a:ext cx="3429000" cy="37620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8"/>
            <p:cNvSpPr/>
            <p:nvPr/>
          </p:nvSpPr>
          <p:spPr>
            <a:xfrm>
              <a:off x="2744280" y="1157040"/>
              <a:ext cx="740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Moc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8"/>
            <p:cNvSpPr/>
            <p:nvPr/>
          </p:nvSpPr>
          <p:spPr>
            <a:xfrm>
              <a:off x="4129560" y="1143000"/>
              <a:ext cx="196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DNA-PKcs siR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Line 19"/>
            <p:cNvSpPr/>
            <p:nvPr/>
          </p:nvSpPr>
          <p:spPr>
            <a:xfrm>
              <a:off x="3581280" y="1471320"/>
              <a:ext cx="31240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TextBox 20"/>
          <p:cNvSpPr/>
          <p:nvPr/>
        </p:nvSpPr>
        <p:spPr>
          <a:xfrm>
            <a:off x="380880" y="5840280"/>
            <a:ext cx="85345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5.B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DNA-PKcs siRNA knockdown resulted in reduction of ATM protein levels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Samples from Figure S5 were also used to evaluate the levels of DNA-PKcs, ATM and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by western blot at the indicated times after transfection.  Percentages of protein remaining are shown below; all values were normaliz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nd the mock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Text Box 3"/>
          <p:cNvSpPr/>
          <p:nvPr/>
        </p:nvSpPr>
        <p:spPr>
          <a:xfrm>
            <a:off x="3376080" y="609480"/>
            <a:ext cx="240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10"/>
          <p:cNvSpPr/>
          <p:nvPr/>
        </p:nvSpPr>
        <p:spPr>
          <a:xfrm>
            <a:off x="7238880" y="3276720"/>
            <a:ext cx="16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tankyras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2" name="Group 19"/>
          <p:cNvGrpSpPr/>
          <p:nvPr/>
        </p:nvGrpSpPr>
        <p:grpSpPr>
          <a:xfrm>
            <a:off x="762120" y="1219320"/>
            <a:ext cx="8076960" cy="4315320"/>
            <a:chOff x="762120" y="1219320"/>
            <a:chExt cx="8076960" cy="4315320"/>
          </a:xfrm>
        </p:grpSpPr>
        <p:pic>
          <p:nvPicPr>
            <p:cNvPr id="153" name="Content Placeholder 4" descr="TknockATMtank180.jpg"/>
            <p:cNvPicPr/>
            <p:nvPr/>
          </p:nvPicPr>
          <p:blipFill>
            <a:blip r:embed="rId1"/>
            <a:stretch/>
          </p:blipFill>
          <p:spPr>
            <a:xfrm>
              <a:off x="1676520" y="2052720"/>
              <a:ext cx="5400720" cy="1704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4" name="Picture 2" descr=""/>
            <p:cNvPicPr/>
            <p:nvPr/>
          </p:nvPicPr>
          <p:blipFill>
            <a:blip r:embed="rId2"/>
            <a:stretch/>
          </p:blipFill>
          <p:spPr>
            <a:xfrm>
              <a:off x="1752480" y="3962520"/>
              <a:ext cx="5371920" cy="91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Rectangle 8"/>
            <p:cNvSpPr/>
            <p:nvPr/>
          </p:nvSpPr>
          <p:spPr>
            <a:xfrm>
              <a:off x="1676520" y="2057400"/>
              <a:ext cx="75960" cy="1676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Box 9"/>
            <p:cNvSpPr/>
            <p:nvPr/>
          </p:nvSpPr>
          <p:spPr>
            <a:xfrm>
              <a:off x="1676520" y="1600200"/>
              <a:ext cx="5333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marker   Mock      M/P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     T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    T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/P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           T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      T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S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/P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10"/>
            <p:cNvSpPr/>
            <p:nvPr/>
          </p:nvSpPr>
          <p:spPr>
            <a:xfrm>
              <a:off x="7238880" y="236232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AT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11"/>
            <p:cNvSpPr/>
            <p:nvPr/>
          </p:nvSpPr>
          <p:spPr>
            <a:xfrm>
              <a:off x="2552760" y="4953240"/>
              <a:ext cx="6286320" cy="58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 100          100          99            101          101         ATM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     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</a:rPr>
                <a:t>100          100            4             4                2             16         tankyrase 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12"/>
            <p:cNvSpPr/>
            <p:nvPr/>
          </p:nvSpPr>
          <p:spPr>
            <a:xfrm>
              <a:off x="762120" y="2590920"/>
              <a:ext cx="927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250 k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Box 13"/>
            <p:cNvSpPr/>
            <p:nvPr/>
          </p:nvSpPr>
          <p:spPr>
            <a:xfrm>
              <a:off x="762120" y="3353040"/>
              <a:ext cx="990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</a:rPr>
                <a:t>150 kD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Box 14"/>
            <p:cNvSpPr/>
            <p:nvPr/>
          </p:nvSpPr>
          <p:spPr>
            <a:xfrm>
              <a:off x="3733920" y="1219320"/>
              <a:ext cx="43434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</a:rPr>
                <a:t>24 hr                            48 h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13"/>
            <p:cNvSpPr/>
            <p:nvPr/>
          </p:nvSpPr>
          <p:spPr>
            <a:xfrm>
              <a:off x="2971800" y="1600200"/>
              <a:ext cx="2286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4"/>
            <p:cNvSpPr/>
            <p:nvPr/>
          </p:nvSpPr>
          <p:spPr>
            <a:xfrm>
              <a:off x="5638680" y="1600200"/>
              <a:ext cx="1218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Box 10"/>
            <p:cNvSpPr/>
            <p:nvPr/>
          </p:nvSpPr>
          <p:spPr>
            <a:xfrm>
              <a:off x="7238880" y="4267440"/>
              <a:ext cx="838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actin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17"/>
            <p:cNvSpPr/>
            <p:nvPr/>
          </p:nvSpPr>
          <p:spPr>
            <a:xfrm>
              <a:off x="2590920" y="2290680"/>
              <a:ext cx="4462200" cy="37620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18"/>
            <p:cNvSpPr/>
            <p:nvPr/>
          </p:nvSpPr>
          <p:spPr>
            <a:xfrm>
              <a:off x="2601720" y="3260880"/>
              <a:ext cx="4452840" cy="37620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7" name="TextBox 20"/>
          <p:cNvSpPr/>
          <p:nvPr/>
        </p:nvSpPr>
        <p:spPr>
          <a:xfrm>
            <a:off x="304920" y="5951520"/>
            <a:ext cx="86104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6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TM protein levels are not affected by tankyrase 1 siRNA knockdow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 WTK1 lymphoblasts were treated with tankyrase 1 siRNA (TS), and/or the DNA-PKcs inhibitor (PI), or the two combined (TS/PI).  Western blot analysis for ATM, tankyrase 1, or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t 24 and 48 hr post transfection is shown.  Percentages of protein remaining are shown below; all values were normalized to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 and the mock transfectio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TextBox 1"/>
          <p:cNvSpPr/>
          <p:nvPr/>
        </p:nvSpPr>
        <p:spPr>
          <a:xfrm>
            <a:off x="1219320" y="609480"/>
            <a:ext cx="670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69" name="Object 2"/>
          <p:cNvGraphicFramePr/>
          <p:nvPr/>
        </p:nvGraphicFramePr>
        <p:xfrm>
          <a:off x="1752480" y="1523880"/>
          <a:ext cx="5826240" cy="4453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70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52480" y="1523880"/>
                    <a:ext cx="5826240" cy="4453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71" name="TextBox 3"/>
          <p:cNvSpPr/>
          <p:nvPr/>
        </p:nvSpPr>
        <p:spPr>
          <a:xfrm>
            <a:off x="519120" y="6172200"/>
            <a:ext cx="80913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.7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eatment with high concentrations of the general PARP inhibitor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3-AB (10 and 20 mM) resulted in lower levels of DNA-PKcs protein as compared to untreated controls; tankyrase 1 protein levels were not affected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7T16:11:41Z</dcterms:created>
  <dc:creator>hliber</dc:creator>
  <dc:description/>
  <dc:language>en-US</dc:language>
  <cp:lastModifiedBy>Susan  Bailey</cp:lastModifiedBy>
  <cp:lastPrinted>2010-07-02T18:44:07Z</cp:lastPrinted>
  <dcterms:modified xsi:type="dcterms:W3CDTF">2010-09-07T21:10:33Z</dcterms:modified>
  <cp:revision>38</cp:revision>
  <dc:subject/>
  <dc:title>Slide 1</dc:title>
</cp:coreProperties>
</file>